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72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17C398-446C-89C9-CD4F-D481B2171A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44EC3C0-3457-B9A5-6C0A-9E29764F3C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6A527F-057E-9642-760F-61AB0B81C8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450135-1EE7-150C-1744-37784C632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BE53F1-670B-EB0B-973E-C2063C891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2722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DB90F7-1B42-E9DA-6CDD-30C0824477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CC417EB-EEF6-A91A-6247-56131B4EB4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0ADD763-AB42-B1D0-E7C2-3FD1FEDF0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06CA35-8E8A-6CA9-DCE8-240AD81B9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ECA488A-BD7D-4FFC-6348-6911DCD25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335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ED70891-3D86-F6A5-8B8D-1F43AC815B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660C76C-C7FD-24A2-3E3F-74C4698789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A294773-56B7-4682-36BE-FB6EA4F85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5FF9A3C-D6DF-0B7F-773A-10927E520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D7E81A-1771-F9E7-099A-B814ECBA9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8990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645EA7-D92E-4437-E4AC-333F4B5D8D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55146BC-A685-A0F0-4511-7516D27F1C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0FCB11-5FB3-37E3-D2BF-13A63E9B6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B26B01-4244-FB68-DEEC-2A995FFB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33EEB5-E176-9B0B-B40E-F5C422324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1323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C1B706-C7EB-3409-A3F3-B886F27F0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A0BB398-3BF2-1010-1D42-46689F4D3B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6FEC33F-3DE8-718D-B708-585DB0B6F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FDD14D-4363-65E0-1146-1207C96249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1EA622-FCDA-99EE-E35D-B8F225AAA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787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867601-12B0-E596-4F6E-9C92F23BDC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DBC8D0E-1686-5E55-EABB-80F3763BA8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ACA71B8-4D1A-08F9-6DB6-2B5D742668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3AF960C-528B-E051-CA97-9DB562B28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519E616-77B5-C7BA-E091-790A8EA18C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1F137C-4C67-E10B-B158-246DE37E4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9177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E13A4B-7543-A476-27AC-E764614550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3CDD8FB-8CCB-050B-B9F8-441C5BCC83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E45DD38-1760-E910-ECCF-C4226F6C44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175415A-753B-E866-7A82-D985ED6056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38EF188-000E-CBE2-E74E-A767B24004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52F964F-54FA-ED83-AE11-54634AD71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A9EE529-3A72-47BB-89CA-E030C25561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3C9E5C1-9CCE-6B8E-E956-BFA4F2F913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3924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4353AE-B708-6470-057A-D3C56A9236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F991EF6-1560-DD75-D6F8-43B17FB4A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86889E4-7EBA-1FB9-6E48-0F1DE3D36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D4FD414-2111-60D4-1391-1C7BE0ED1B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1203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FAC60E0-F7F1-DA4E-1DC4-2B69E2775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6EBF515-218B-9D7B-B2DE-6A8370D83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A732F6D-1526-7540-832E-8506C0B3F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9397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1E1E07-7689-A40F-397F-CD03356179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0DD2750-0D51-0FB6-D8F6-500CB25A9C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5DCDDB7-8FF9-4EB7-6B26-6DE4FBE3A7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7878656-82CC-CE49-95DF-5B6D275C1B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5E8CCB-99B7-60FA-F27F-E4542509B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25CC2F8-CA26-7DCE-C035-4D9AF842C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2106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A29667-51C3-39A9-8E6C-4A61C0F22B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3569B25-3391-52A5-5DFE-5EE8D391BC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2D7F759-8AD5-286B-113C-78E6DE21E0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2CF5C0B-CC61-4B39-54B7-043CE0BF1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02F6E11-B540-E2F5-D522-5C835E39F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E30D54-8333-AFEE-B3F6-2947AA22C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99210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D61EBAB-64F1-AA45-6E39-A754BA358D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D8CDCE8-E1C3-B0DA-5A68-8D9FB6283E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673EDC-7265-1A37-B6D8-E7DE11B384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DB296-8ACF-4DB1-BE41-6FF087F797B8}" type="datetimeFigureOut">
              <a:rPr lang="zh-CN" altLang="en-US" smtClean="0"/>
              <a:t>2024/3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8EA588-4836-E9FD-6683-2E1DF5F159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E0530B5-55AF-E69B-2B7C-46153AEFD9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2396D-E9C3-4E54-933E-8720CD534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1686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4A4968-FEF5-A3D2-4FEA-566C4421488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/>
              <a:t>WB Result</a:t>
            </a:r>
            <a:endParaRPr lang="zh-CN" altLang="en-US" dirty="0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B9DEDE6-A668-3C11-2414-A60E2CA9118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12465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AC9BAC07-F7E9-C972-4E20-28B3E7C9441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46807"/>
            <a:ext cx="6599583" cy="5508974"/>
          </a:xfrm>
        </p:spPr>
      </p:pic>
      <p:sp>
        <p:nvSpPr>
          <p:cNvPr id="2" name="标题 1">
            <a:extLst>
              <a:ext uri="{FF2B5EF4-FFF2-40B4-BE49-F238E27FC236}">
                <a16:creationId xmlns:a16="http://schemas.microsoft.com/office/drawing/2014/main" id="{F40F1330-C2FF-7651-DA76-D7F94782C6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ZO-1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8A03393A-AD07-65F5-0F13-44B4136EEF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0782" y="1169025"/>
            <a:ext cx="6599582" cy="5508974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77E6ED49-D2C3-1EB7-B86E-0BFDF93A4D37}"/>
              </a:ext>
            </a:extLst>
          </p:cNvPr>
          <p:cNvSpPr txBox="1"/>
          <p:nvPr/>
        </p:nvSpPr>
        <p:spPr>
          <a:xfrm rot="18059177">
            <a:off x="3199863" y="2384075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1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8BEF751-60A2-32D7-E9D7-CB4C857D2A26}"/>
              </a:ext>
            </a:extLst>
          </p:cNvPr>
          <p:cNvSpPr txBox="1"/>
          <p:nvPr/>
        </p:nvSpPr>
        <p:spPr>
          <a:xfrm rot="18059177">
            <a:off x="3560864" y="2419970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2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E22FFBB-923E-93AC-4F1C-92380AF43934}"/>
              </a:ext>
            </a:extLst>
          </p:cNvPr>
          <p:cNvSpPr txBox="1"/>
          <p:nvPr/>
        </p:nvSpPr>
        <p:spPr>
          <a:xfrm rot="18059177">
            <a:off x="4048145" y="2419970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LP1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26E4702-2B4D-F874-5859-525690550CC8}"/>
              </a:ext>
            </a:extLst>
          </p:cNvPr>
          <p:cNvSpPr txBox="1"/>
          <p:nvPr/>
        </p:nvSpPr>
        <p:spPr>
          <a:xfrm rot="18059177">
            <a:off x="4449666" y="2419971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LP2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37E76A8-C9B1-8161-B07F-79FE6E1068D2}"/>
              </a:ext>
            </a:extLst>
          </p:cNvPr>
          <p:cNvSpPr txBox="1"/>
          <p:nvPr/>
        </p:nvSpPr>
        <p:spPr>
          <a:xfrm rot="18059177">
            <a:off x="4938005" y="2434105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A1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670B1A8-E239-B854-251B-C60933B44698}"/>
              </a:ext>
            </a:extLst>
          </p:cNvPr>
          <p:cNvSpPr txBox="1"/>
          <p:nvPr/>
        </p:nvSpPr>
        <p:spPr>
          <a:xfrm rot="18059177">
            <a:off x="5391451" y="244267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A2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38DA8F5-0257-C2E9-F187-ACF695770C03}"/>
              </a:ext>
            </a:extLst>
          </p:cNvPr>
          <p:cNvSpPr txBox="1"/>
          <p:nvPr/>
        </p:nvSpPr>
        <p:spPr>
          <a:xfrm rot="18059177">
            <a:off x="9415953" y="2241449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LP3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2906985-09F5-7A50-00CC-6F58FF56E5E9}"/>
              </a:ext>
            </a:extLst>
          </p:cNvPr>
          <p:cNvSpPr txBox="1"/>
          <p:nvPr/>
        </p:nvSpPr>
        <p:spPr>
          <a:xfrm rot="18059177">
            <a:off x="9904292" y="225558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A3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1F8E221-51CB-8553-5620-D0D069CF49CE}"/>
              </a:ext>
            </a:extLst>
          </p:cNvPr>
          <p:cNvSpPr txBox="1"/>
          <p:nvPr/>
        </p:nvSpPr>
        <p:spPr>
          <a:xfrm rot="18059177">
            <a:off x="8930420" y="2241447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272827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198C45C2-F33E-3A2D-1FA8-B65B0DEFEF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5138" y="1093912"/>
            <a:ext cx="6786862" cy="5665304"/>
          </a:xfrm>
          <a:prstGeom prst="rect">
            <a:avLst/>
          </a:prstGeom>
        </p:spPr>
      </p:pic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7DC6BB5B-4387-DE76-6609-3DCA2644C1C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782" y="1093912"/>
            <a:ext cx="6887818" cy="5749578"/>
          </a:xfrm>
        </p:spPr>
      </p:pic>
      <p:sp>
        <p:nvSpPr>
          <p:cNvPr id="2" name="标题 1">
            <a:extLst>
              <a:ext uri="{FF2B5EF4-FFF2-40B4-BE49-F238E27FC236}">
                <a16:creationId xmlns:a16="http://schemas.microsoft.com/office/drawing/2014/main" id="{F40F1330-C2FF-7651-DA76-D7F94782C6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err="1"/>
              <a:t>Ocludin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4C6241B-4AC7-DFEC-2D44-D7E9FF102A39}"/>
              </a:ext>
            </a:extLst>
          </p:cNvPr>
          <p:cNvSpPr txBox="1"/>
          <p:nvPr/>
        </p:nvSpPr>
        <p:spPr>
          <a:xfrm rot="18059177">
            <a:off x="3020958" y="2463587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1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011714E-1CFA-3A8B-B603-AE1921E1C223}"/>
              </a:ext>
            </a:extLst>
          </p:cNvPr>
          <p:cNvSpPr txBox="1"/>
          <p:nvPr/>
        </p:nvSpPr>
        <p:spPr>
          <a:xfrm rot="18059177">
            <a:off x="3381959" y="2499482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2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689C378-2A2A-2D62-36F8-008BFFCF9890}"/>
              </a:ext>
            </a:extLst>
          </p:cNvPr>
          <p:cNvSpPr txBox="1"/>
          <p:nvPr/>
        </p:nvSpPr>
        <p:spPr>
          <a:xfrm rot="18059177">
            <a:off x="3869240" y="2499482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LP1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537E087-5D94-448B-0E48-249A77C38250}"/>
              </a:ext>
            </a:extLst>
          </p:cNvPr>
          <p:cNvSpPr txBox="1"/>
          <p:nvPr/>
        </p:nvSpPr>
        <p:spPr>
          <a:xfrm rot="18059177">
            <a:off x="4270761" y="2499483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LP2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FA7A9B4-31F0-4C8D-EFFC-00C9978F9562}"/>
              </a:ext>
            </a:extLst>
          </p:cNvPr>
          <p:cNvSpPr txBox="1"/>
          <p:nvPr/>
        </p:nvSpPr>
        <p:spPr>
          <a:xfrm rot="18059177">
            <a:off x="4759100" y="251361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A1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E7FB86B-7982-2DBB-B4EF-C9637C9B52B5}"/>
              </a:ext>
            </a:extLst>
          </p:cNvPr>
          <p:cNvSpPr txBox="1"/>
          <p:nvPr/>
        </p:nvSpPr>
        <p:spPr>
          <a:xfrm rot="18059177">
            <a:off x="5212546" y="2522189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A2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FE1D912-FF78-6E39-778C-C6684351D54A}"/>
              </a:ext>
            </a:extLst>
          </p:cNvPr>
          <p:cNvSpPr txBox="1"/>
          <p:nvPr/>
        </p:nvSpPr>
        <p:spPr>
          <a:xfrm rot="18059177">
            <a:off x="8909056" y="2241449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LP3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86C2F98-B8E0-192B-29D2-0E89148BF604}"/>
              </a:ext>
            </a:extLst>
          </p:cNvPr>
          <p:cNvSpPr txBox="1"/>
          <p:nvPr/>
        </p:nvSpPr>
        <p:spPr>
          <a:xfrm rot="18059177">
            <a:off x="9397395" y="225558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A3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999A043-C4E2-0DC3-0285-1B1E592B6E5B}"/>
              </a:ext>
            </a:extLst>
          </p:cNvPr>
          <p:cNvSpPr txBox="1"/>
          <p:nvPr/>
        </p:nvSpPr>
        <p:spPr>
          <a:xfrm rot="18059177">
            <a:off x="8423523" y="2241447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659210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E00CC2-A6B6-D990-A11A-A3C643D12C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dirty="0"/>
              <a:t>组图</a:t>
            </a: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888621E9-6960-4422-EBDD-537D47F6376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78199121"/>
              </p:ext>
            </p:extLst>
          </p:nvPr>
        </p:nvGraphicFramePr>
        <p:xfrm>
          <a:off x="1410176" y="3193829"/>
          <a:ext cx="593432" cy="271780"/>
        </p:xfrm>
        <a:graphic>
          <a:graphicData uri="http://schemas.openxmlformats.org/drawingml/2006/table">
            <a:tbl>
              <a:tblPr/>
              <a:tblGrid>
                <a:gridCol w="5934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 algn="r">
                        <a:buNone/>
                      </a:pPr>
                      <a:r>
                        <a:rPr lang="en-US" altLang="zh-CN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ZO</a:t>
                      </a: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-1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3B9D5037-01FA-8D43-74B6-E3A3D206C9F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00296997"/>
              </p:ext>
            </p:extLst>
          </p:nvPr>
        </p:nvGraphicFramePr>
        <p:xfrm>
          <a:off x="1293854" y="3901219"/>
          <a:ext cx="709118" cy="271780"/>
        </p:xfrm>
        <a:graphic>
          <a:graphicData uri="http://schemas.openxmlformats.org/drawingml/2006/table">
            <a:tbl>
              <a:tblPr/>
              <a:tblGrid>
                <a:gridCol w="7091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 algn="r">
                        <a:buNone/>
                      </a:pPr>
                      <a:r>
                        <a:rPr lang="en-US" sz="1400" b="0" dirty="0" err="1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Ocludin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6" name="图片 5">
            <a:extLst>
              <a:ext uri="{FF2B5EF4-FFF2-40B4-BE49-F238E27FC236}">
                <a16:creationId xmlns:a16="http://schemas.microsoft.com/office/drawing/2014/main" id="{9ED12B67-345D-22CB-CB06-06DF2B664B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751"/>
          <a:stretch/>
        </p:blipFill>
        <p:spPr>
          <a:xfrm>
            <a:off x="2066014" y="3210339"/>
            <a:ext cx="1380490" cy="25908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EC2DE46-EFCE-1E32-4275-B42E23F8C4F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751"/>
          <a:stretch/>
        </p:blipFill>
        <p:spPr>
          <a:xfrm>
            <a:off x="2066012" y="3557684"/>
            <a:ext cx="1380491" cy="262255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90B4B71-05A1-17E8-D4B0-0CF38C082E9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5726"/>
          <a:stretch/>
        </p:blipFill>
        <p:spPr>
          <a:xfrm>
            <a:off x="2064742" y="3908204"/>
            <a:ext cx="1380491" cy="25844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F4F0018-9516-2BD6-B120-A2B638A35B8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5708"/>
          <a:stretch/>
        </p:blipFill>
        <p:spPr>
          <a:xfrm>
            <a:off x="2064742" y="4254914"/>
            <a:ext cx="1381761" cy="252095"/>
          </a:xfrm>
          <a:prstGeom prst="rect">
            <a:avLst/>
          </a:prstGeom>
        </p:spPr>
      </p:pic>
      <p:graphicFrame>
        <p:nvGraphicFramePr>
          <p:cNvPr id="10" name="表格 9">
            <a:extLst>
              <a:ext uri="{FF2B5EF4-FFF2-40B4-BE49-F238E27FC236}">
                <a16:creationId xmlns:a16="http://schemas.microsoft.com/office/drawing/2014/main" id="{7D6E0244-9A31-EE2B-3A7E-49EB8AD4663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96494856"/>
              </p:ext>
            </p:extLst>
          </p:nvPr>
        </p:nvGraphicFramePr>
        <p:xfrm>
          <a:off x="1410176" y="3557684"/>
          <a:ext cx="593432" cy="271780"/>
        </p:xfrm>
        <a:graphic>
          <a:graphicData uri="http://schemas.openxmlformats.org/drawingml/2006/table">
            <a:tbl>
              <a:tblPr/>
              <a:tblGrid>
                <a:gridCol w="5934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 algn="r">
                        <a:buNone/>
                      </a:pPr>
                      <a:r>
                        <a:rPr lang="en-US" sz="1400" b="0" dirty="0" err="1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Gapdh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1" name="表格 10">
            <a:extLst>
              <a:ext uri="{FF2B5EF4-FFF2-40B4-BE49-F238E27FC236}">
                <a16:creationId xmlns:a16="http://schemas.microsoft.com/office/drawing/2014/main" id="{A302B266-9B64-2753-658A-07A115718D1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526317845"/>
              </p:ext>
            </p:extLst>
          </p:nvPr>
        </p:nvGraphicFramePr>
        <p:xfrm>
          <a:off x="1409540" y="4254914"/>
          <a:ext cx="593432" cy="271780"/>
        </p:xfrm>
        <a:graphic>
          <a:graphicData uri="http://schemas.openxmlformats.org/drawingml/2006/table">
            <a:tbl>
              <a:tblPr/>
              <a:tblGrid>
                <a:gridCol w="5934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 algn="r">
                        <a:buNone/>
                      </a:pPr>
                      <a:r>
                        <a:rPr lang="en-US" sz="1400" b="0" dirty="0" err="1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Gapdh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12" name="文本框 11">
            <a:extLst>
              <a:ext uri="{FF2B5EF4-FFF2-40B4-BE49-F238E27FC236}">
                <a16:creationId xmlns:a16="http://schemas.microsoft.com/office/drawing/2014/main" id="{5B51942F-8EE3-FE02-00EF-8B8696752ACB}"/>
              </a:ext>
            </a:extLst>
          </p:cNvPr>
          <p:cNvSpPr txBox="1"/>
          <p:nvPr/>
        </p:nvSpPr>
        <p:spPr>
          <a:xfrm>
            <a:off x="2486463" y="2894096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P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6C91D0F-E932-448B-ACF8-3937B937583A}"/>
              </a:ext>
            </a:extLst>
          </p:cNvPr>
          <p:cNvSpPr txBox="1"/>
          <p:nvPr/>
        </p:nvSpPr>
        <p:spPr>
          <a:xfrm>
            <a:off x="2974972" y="2894096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E6D49A0-76BC-4107-A0CB-3076536C0130}"/>
              </a:ext>
            </a:extLst>
          </p:cNvPr>
          <p:cNvSpPr txBox="1"/>
          <p:nvPr/>
        </p:nvSpPr>
        <p:spPr>
          <a:xfrm>
            <a:off x="2009261" y="2894096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5" name="表格 14">
            <a:extLst>
              <a:ext uri="{FF2B5EF4-FFF2-40B4-BE49-F238E27FC236}">
                <a16:creationId xmlns:a16="http://schemas.microsoft.com/office/drawing/2014/main" id="{105DCF5C-8B96-AE67-E8EF-D9480AF4721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732618342"/>
              </p:ext>
            </p:extLst>
          </p:nvPr>
        </p:nvGraphicFramePr>
        <p:xfrm>
          <a:off x="3485755" y="3193829"/>
          <a:ext cx="709118" cy="271780"/>
        </p:xfrm>
        <a:graphic>
          <a:graphicData uri="http://schemas.openxmlformats.org/drawingml/2006/table">
            <a:tbl>
              <a:tblPr/>
              <a:tblGrid>
                <a:gridCol w="7091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altLang="zh-CN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195kDa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6" name="表格 15">
            <a:extLst>
              <a:ext uri="{FF2B5EF4-FFF2-40B4-BE49-F238E27FC236}">
                <a16:creationId xmlns:a16="http://schemas.microsoft.com/office/drawing/2014/main" id="{3DDAB4AC-1A31-8472-F481-7C642C41927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039339010"/>
              </p:ext>
            </p:extLst>
          </p:nvPr>
        </p:nvGraphicFramePr>
        <p:xfrm>
          <a:off x="3485755" y="3901219"/>
          <a:ext cx="709118" cy="271780"/>
        </p:xfrm>
        <a:graphic>
          <a:graphicData uri="http://schemas.openxmlformats.org/drawingml/2006/table">
            <a:tbl>
              <a:tblPr/>
              <a:tblGrid>
                <a:gridCol w="7091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59kDa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7" name="表格 16">
            <a:extLst>
              <a:ext uri="{FF2B5EF4-FFF2-40B4-BE49-F238E27FC236}">
                <a16:creationId xmlns:a16="http://schemas.microsoft.com/office/drawing/2014/main" id="{CC4FF5E0-377F-658F-4D01-4D26B539A28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835799494"/>
              </p:ext>
            </p:extLst>
          </p:nvPr>
        </p:nvGraphicFramePr>
        <p:xfrm>
          <a:off x="3485755" y="3557684"/>
          <a:ext cx="593432" cy="271780"/>
        </p:xfrm>
        <a:graphic>
          <a:graphicData uri="http://schemas.openxmlformats.org/drawingml/2006/table">
            <a:tbl>
              <a:tblPr/>
              <a:tblGrid>
                <a:gridCol w="5934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indent="0" algn="l">
                        <a:buNone/>
                      </a:pP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36kDa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8" name="表格 17">
            <a:extLst>
              <a:ext uri="{FF2B5EF4-FFF2-40B4-BE49-F238E27FC236}">
                <a16:creationId xmlns:a16="http://schemas.microsoft.com/office/drawing/2014/main" id="{AC6FC6AD-F1C6-6F59-8519-83DC3BE35D6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61045671"/>
              </p:ext>
            </p:extLst>
          </p:nvPr>
        </p:nvGraphicFramePr>
        <p:xfrm>
          <a:off x="3485755" y="4265074"/>
          <a:ext cx="593432" cy="271780"/>
        </p:xfrm>
        <a:graphic>
          <a:graphicData uri="http://schemas.openxmlformats.org/drawingml/2006/table">
            <a:tbl>
              <a:tblPr/>
              <a:tblGrid>
                <a:gridCol w="5934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159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b="0" dirty="0">
                          <a:solidFill>
                            <a:srgbClr val="000000"/>
                          </a:solidFill>
                          <a:latin typeface="Arial" panose="020B0604020202020204" charset="-122"/>
                        </a:rPr>
                        <a:t>36kDa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Arial" panose="020B0604020202020204" charset="-122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42403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宽屏</PresentationFormat>
  <Paragraphs>3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WB Result</vt:lpstr>
      <vt:lpstr>ZO-1</vt:lpstr>
      <vt:lpstr>Ocludin</vt:lpstr>
      <vt:lpstr>组图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B Result</dc:title>
  <dc:creator>Dream Amber</dc:creator>
  <cp:lastModifiedBy>Dream Amber</cp:lastModifiedBy>
  <cp:revision>1</cp:revision>
  <dcterms:created xsi:type="dcterms:W3CDTF">2024-03-11T13:29:58Z</dcterms:created>
  <dcterms:modified xsi:type="dcterms:W3CDTF">2024-03-11T13:30:05Z</dcterms:modified>
</cp:coreProperties>
</file>